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CDBE4533-5B9D-4EDB-97E2-67A1ACDDDCEA}"/>
    <pc:docChg chg="custSel addSld modSld">
      <pc:chgData name="Tekle Pauzaite" userId="06f7e524-8501-4f81-9b2a-484f6f2c7061" providerId="ADAL" clId="{CDBE4533-5B9D-4EDB-97E2-67A1ACDDDCEA}" dt="2024-03-27T14:19:52.160" v="149" actId="571"/>
      <pc:docMkLst>
        <pc:docMk/>
      </pc:docMkLst>
      <pc:sldChg chg="addSp delSp modSp add">
        <pc:chgData name="Tekle Pauzaite" userId="06f7e524-8501-4f81-9b2a-484f6f2c7061" providerId="ADAL" clId="{CDBE4533-5B9D-4EDB-97E2-67A1ACDDDCEA}" dt="2024-03-27T14:17:12.016" v="70" actId="571"/>
        <pc:sldMkLst>
          <pc:docMk/>
          <pc:sldMk cId="3168164263" sldId="256"/>
        </pc:sldMkLst>
        <pc:spChg chg="del">
          <ac:chgData name="Tekle Pauzaite" userId="06f7e524-8501-4f81-9b2a-484f6f2c7061" providerId="ADAL" clId="{CDBE4533-5B9D-4EDB-97E2-67A1ACDDDCEA}" dt="2024-03-27T14:14:41.202" v="1"/>
          <ac:spMkLst>
            <pc:docMk/>
            <pc:sldMk cId="3168164263" sldId="256"/>
            <ac:spMk id="2" creationId="{6FB48DB9-1A36-401D-9826-3FFFCD45BCEF}"/>
          </ac:spMkLst>
        </pc:spChg>
        <pc:spChg chg="del">
          <ac:chgData name="Tekle Pauzaite" userId="06f7e524-8501-4f81-9b2a-484f6f2c7061" providerId="ADAL" clId="{CDBE4533-5B9D-4EDB-97E2-67A1ACDDDCEA}" dt="2024-03-27T14:14:41.202" v="1"/>
          <ac:spMkLst>
            <pc:docMk/>
            <pc:sldMk cId="3168164263" sldId="256"/>
            <ac:spMk id="3" creationId="{B6AEAAC1-D0EE-4F08-A5F4-C7ADD2A17993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" creationId="{5F5F8BDC-1DC5-40C8-9977-A2F5BAC37D19}"/>
          </ac:spMkLst>
        </pc:spChg>
        <pc:spChg chg="add del mod">
          <ac:chgData name="Tekle Pauzaite" userId="06f7e524-8501-4f81-9b2a-484f6f2c7061" providerId="ADAL" clId="{CDBE4533-5B9D-4EDB-97E2-67A1ACDDDCEA}" dt="2024-03-27T14:15:01.845" v="8" actId="478"/>
          <ac:spMkLst>
            <pc:docMk/>
            <pc:sldMk cId="3168164263" sldId="256"/>
            <ac:spMk id="5" creationId="{89427614-353A-47FA-9F20-19ACE2AB37A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0" creationId="{A8DDEB40-C8CF-43A1-9333-C236CBE8E1D8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1" creationId="{11469A2D-FE4C-4268-8134-52642B9D14F0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2" creationId="{39C90505-9C8E-47AA-86E1-01FC4C03B8C5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3" creationId="{916C9802-6D18-45E0-88F9-0120D8E782D8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4" creationId="{677D4030-4444-4659-A36E-3A024FFF2D01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5" creationId="{DBD2AB0A-6834-46A7-BAFC-94E6CB0724F1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6" creationId="{8AF2EE96-97B1-4592-8B5E-AD3D21056185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7" creationId="{6FF2BD75-8DB2-4FEB-B6DD-C2338C1C9CA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8" creationId="{42F86C1A-20DE-4832-B588-34A735E6BE16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19" creationId="{539C6792-F0E6-466A-8AC7-EC709F695B00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0" creationId="{F742D2F3-AE6C-4B06-9F02-AB030EC9627A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1" creationId="{611A33A2-D8E7-4011-A1EA-D5FD272F3671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2" creationId="{DAA2995B-F86A-4EA7-B025-EE12397115AE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3" creationId="{9D6B3969-2D0F-4876-90EE-BA87FF537BCD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4" creationId="{B504E476-0F1D-4B11-B4DF-08F80DB356B7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6" creationId="{728C6217-D6EF-4930-975B-0F4E648AAD1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7" creationId="{025836D1-6086-42E5-9349-0ADDD96454F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8" creationId="{5EABB870-02BE-4096-9F11-F21D36B02C1F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29" creationId="{3AD7F12E-5F43-430D-8AE7-7E1E33090B7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30" creationId="{B3B288FD-2C1A-46BC-B574-BEBE6BA97E00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31" creationId="{8C6A2F46-3B56-4DDA-AC8A-204BC8A69A4A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32" creationId="{8560F114-0B55-4079-95EB-1F9692710703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37" creationId="{3BB9288A-B131-4550-B47F-DAB848F9A7FB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39" creationId="{BA6137E0-2FEF-43A2-861B-D54F9E9888BC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0" creationId="{4F536286-ED89-4409-8803-D06DE661DF41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1" creationId="{64591582-0FD0-481B-984F-6FE753FD7A88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2" creationId="{6349337C-819E-4414-9A26-7DB8CEBED212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3" creationId="{2413B278-6C8E-42CF-B659-586B3103278B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4" creationId="{ECA965E2-6B5C-491E-847C-AEC5DBCC2A84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5" creationId="{6C5ADEAA-BED6-4F57-B3E0-A5EADF05534D}"/>
          </ac:spMkLst>
        </pc:spChg>
        <pc:spChg chg="add mod">
          <ac:chgData name="Tekle Pauzaite" userId="06f7e524-8501-4f81-9b2a-484f6f2c7061" providerId="ADAL" clId="{CDBE4533-5B9D-4EDB-97E2-67A1ACDDDCEA}" dt="2024-03-27T14:15:05.680" v="9" actId="1076"/>
          <ac:spMkLst>
            <pc:docMk/>
            <pc:sldMk cId="3168164263" sldId="256"/>
            <ac:spMk id="46" creationId="{FF87B009-80E1-4164-9FE0-CD98CCD3F2FE}"/>
          </ac:spMkLst>
        </pc:spChg>
        <pc:spChg chg="add mod">
          <ac:chgData name="Tekle Pauzaite" userId="06f7e524-8501-4f81-9b2a-484f6f2c7061" providerId="ADAL" clId="{CDBE4533-5B9D-4EDB-97E2-67A1ACDDDCEA}" dt="2024-03-27T14:16:35.123" v="59" actId="14100"/>
          <ac:spMkLst>
            <pc:docMk/>
            <pc:sldMk cId="3168164263" sldId="256"/>
            <ac:spMk id="100" creationId="{D8E275D2-E26F-48AC-B2A9-53997DDE23E8}"/>
          </ac:spMkLst>
        </pc:spChg>
        <pc:spChg chg="add mod">
          <ac:chgData name="Tekle Pauzaite" userId="06f7e524-8501-4f81-9b2a-484f6f2c7061" providerId="ADAL" clId="{CDBE4533-5B9D-4EDB-97E2-67A1ACDDDCEA}" dt="2024-03-27T14:16:35.123" v="59" actId="14100"/>
          <ac:spMkLst>
            <pc:docMk/>
            <pc:sldMk cId="3168164263" sldId="256"/>
            <ac:spMk id="101" creationId="{C68C5409-EF30-4F98-A84E-8E501A4201EC}"/>
          </ac:spMkLst>
        </pc:spChg>
        <pc:spChg chg="add mod">
          <ac:chgData name="Tekle Pauzaite" userId="06f7e524-8501-4f81-9b2a-484f6f2c7061" providerId="ADAL" clId="{CDBE4533-5B9D-4EDB-97E2-67A1ACDDDCEA}" dt="2024-03-27T14:16:44.040" v="60" actId="571"/>
          <ac:spMkLst>
            <pc:docMk/>
            <pc:sldMk cId="3168164263" sldId="256"/>
            <ac:spMk id="102" creationId="{F88F5E0A-40F4-4F3A-B9B6-8E6F6E843305}"/>
          </ac:spMkLst>
        </pc:spChg>
        <pc:spChg chg="add mod">
          <ac:chgData name="Tekle Pauzaite" userId="06f7e524-8501-4f81-9b2a-484f6f2c7061" providerId="ADAL" clId="{CDBE4533-5B9D-4EDB-97E2-67A1ACDDDCEA}" dt="2024-03-27T14:16:49.911" v="61" actId="571"/>
          <ac:spMkLst>
            <pc:docMk/>
            <pc:sldMk cId="3168164263" sldId="256"/>
            <ac:spMk id="103" creationId="{76280EEE-81AD-4778-8B9C-5FF060A813EE}"/>
          </ac:spMkLst>
        </pc:spChg>
        <pc:spChg chg="add mod">
          <ac:chgData name="Tekle Pauzaite" userId="06f7e524-8501-4f81-9b2a-484f6f2c7061" providerId="ADAL" clId="{CDBE4533-5B9D-4EDB-97E2-67A1ACDDDCEA}" dt="2024-03-27T14:16:58.574" v="67" actId="1035"/>
          <ac:spMkLst>
            <pc:docMk/>
            <pc:sldMk cId="3168164263" sldId="256"/>
            <ac:spMk id="104" creationId="{AB4B1E2F-B448-4AF0-9426-DF067E19AE31}"/>
          </ac:spMkLst>
        </pc:spChg>
        <pc:spChg chg="add mod">
          <ac:chgData name="Tekle Pauzaite" userId="06f7e524-8501-4f81-9b2a-484f6f2c7061" providerId="ADAL" clId="{CDBE4533-5B9D-4EDB-97E2-67A1ACDDDCEA}" dt="2024-03-27T14:17:02.599" v="68" actId="571"/>
          <ac:spMkLst>
            <pc:docMk/>
            <pc:sldMk cId="3168164263" sldId="256"/>
            <ac:spMk id="105" creationId="{ACC81B0B-0C77-417C-8953-C96FAE9959B7}"/>
          </ac:spMkLst>
        </pc:spChg>
        <pc:spChg chg="add mod">
          <ac:chgData name="Tekle Pauzaite" userId="06f7e524-8501-4f81-9b2a-484f6f2c7061" providerId="ADAL" clId="{CDBE4533-5B9D-4EDB-97E2-67A1ACDDDCEA}" dt="2024-03-27T14:17:07.224" v="69" actId="571"/>
          <ac:spMkLst>
            <pc:docMk/>
            <pc:sldMk cId="3168164263" sldId="256"/>
            <ac:spMk id="106" creationId="{A7830F7D-CE30-4245-A534-926096DA9333}"/>
          </ac:spMkLst>
        </pc:spChg>
        <pc:spChg chg="add mod">
          <ac:chgData name="Tekle Pauzaite" userId="06f7e524-8501-4f81-9b2a-484f6f2c7061" providerId="ADAL" clId="{CDBE4533-5B9D-4EDB-97E2-67A1ACDDDCEA}" dt="2024-03-27T14:17:12.016" v="70" actId="571"/>
          <ac:spMkLst>
            <pc:docMk/>
            <pc:sldMk cId="3168164263" sldId="256"/>
            <ac:spMk id="107" creationId="{386F083D-B52F-462C-BB37-71CC6B1704BC}"/>
          </ac:spMkLst>
        </pc:spChg>
        <pc:grpChg chg="add del mod">
          <ac:chgData name="Tekle Pauzaite" userId="06f7e524-8501-4f81-9b2a-484f6f2c7061" providerId="ADAL" clId="{CDBE4533-5B9D-4EDB-97E2-67A1ACDDDCEA}" dt="2024-03-27T14:14:58.060" v="7" actId="478"/>
          <ac:grpSpMkLst>
            <pc:docMk/>
            <pc:sldMk cId="3168164263" sldId="256"/>
            <ac:grpSpMk id="48" creationId="{C01B941A-628A-41C8-BAD7-AC65F86AB382}"/>
          </ac:grpSpMkLst>
        </pc:grpChg>
        <pc:picChg chg="add mod">
          <ac:chgData name="Tekle Pauzaite" userId="06f7e524-8501-4f81-9b2a-484f6f2c7061" providerId="ADAL" clId="{CDBE4533-5B9D-4EDB-97E2-67A1ACDDDCEA}" dt="2024-03-27T14:15:05.680" v="9" actId="1076"/>
          <ac:picMkLst>
            <pc:docMk/>
            <pc:sldMk cId="3168164263" sldId="256"/>
            <ac:picMk id="6" creationId="{D84312AC-2606-4DC9-BEB7-CDD1B3B97377}"/>
          </ac:picMkLst>
        </pc:picChg>
        <pc:picChg chg="add mod">
          <ac:chgData name="Tekle Pauzaite" userId="06f7e524-8501-4f81-9b2a-484f6f2c7061" providerId="ADAL" clId="{CDBE4533-5B9D-4EDB-97E2-67A1ACDDDCEA}" dt="2024-03-27T14:15:05.680" v="9" actId="1076"/>
          <ac:picMkLst>
            <pc:docMk/>
            <pc:sldMk cId="3168164263" sldId="256"/>
            <ac:picMk id="7" creationId="{6190980C-FC84-4780-8BA9-8797CCECEEAE}"/>
          </ac:picMkLst>
        </pc:picChg>
        <pc:picChg chg="add mod">
          <ac:chgData name="Tekle Pauzaite" userId="06f7e524-8501-4f81-9b2a-484f6f2c7061" providerId="ADAL" clId="{CDBE4533-5B9D-4EDB-97E2-67A1ACDDDCEA}" dt="2024-03-27T14:15:05.680" v="9" actId="1076"/>
          <ac:picMkLst>
            <pc:docMk/>
            <pc:sldMk cId="3168164263" sldId="256"/>
            <ac:picMk id="8" creationId="{A9D00DDA-2FE7-49A1-A5EE-FF848CBC929A}"/>
          </ac:picMkLst>
        </pc:picChg>
        <pc:picChg chg="add mod">
          <ac:chgData name="Tekle Pauzaite" userId="06f7e524-8501-4f81-9b2a-484f6f2c7061" providerId="ADAL" clId="{CDBE4533-5B9D-4EDB-97E2-67A1ACDDDCEA}" dt="2024-03-27T14:15:05.680" v="9" actId="1076"/>
          <ac:picMkLst>
            <pc:docMk/>
            <pc:sldMk cId="3168164263" sldId="256"/>
            <ac:picMk id="9" creationId="{8E6E1338-FCD7-46A2-815B-C3AF7E855F8A}"/>
          </ac:picMkLst>
        </pc:picChg>
        <pc:picChg chg="add mod modCrop">
          <ac:chgData name="Tekle Pauzaite" userId="06f7e524-8501-4f81-9b2a-484f6f2c7061" providerId="ADAL" clId="{CDBE4533-5B9D-4EDB-97E2-67A1ACDDDCEA}" dt="2024-03-27T14:16:13.047" v="51" actId="1076"/>
          <ac:picMkLst>
            <pc:docMk/>
            <pc:sldMk cId="3168164263" sldId="256"/>
            <ac:picMk id="97" creationId="{870AE733-C3DE-41F1-BD75-923E3A22D394}"/>
          </ac:picMkLst>
        </pc:picChg>
        <pc:picChg chg="add mod modCrop">
          <ac:chgData name="Tekle Pauzaite" userId="06f7e524-8501-4f81-9b2a-484f6f2c7061" providerId="ADAL" clId="{CDBE4533-5B9D-4EDB-97E2-67A1ACDDDCEA}" dt="2024-03-27T14:15:45.680" v="36" actId="1076"/>
          <ac:picMkLst>
            <pc:docMk/>
            <pc:sldMk cId="3168164263" sldId="256"/>
            <ac:picMk id="98" creationId="{28125AA3-E5FE-42FB-86DF-A1EFA1E0F004}"/>
          </ac:picMkLst>
        </pc:picChg>
        <pc:picChg chg="add mod modCrop">
          <ac:chgData name="Tekle Pauzaite" userId="06f7e524-8501-4f81-9b2a-484f6f2c7061" providerId="ADAL" clId="{CDBE4533-5B9D-4EDB-97E2-67A1ACDDDCEA}" dt="2024-03-27T14:16:08.511" v="49" actId="1076"/>
          <ac:picMkLst>
            <pc:docMk/>
            <pc:sldMk cId="3168164263" sldId="256"/>
            <ac:picMk id="99" creationId="{602F0A40-66C7-4634-BE28-8E8F0D82ABD2}"/>
          </ac:picMkLst>
        </pc:pic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25" creationId="{3EE873AA-DCFB-4DEF-BFD6-17689FDC5BA9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33" creationId="{C9D9E926-C8C1-45C6-B13F-84CE2200A4C4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34" creationId="{17A90729-B5B0-4C5C-B15B-66403A55AEBB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35" creationId="{1FE093B1-5D36-46DE-85DD-FD4C76110D65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36" creationId="{06D429A4-6A20-4467-9706-D91CC4539B3F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38" creationId="{536EC2B9-E71B-4638-B8EB-9F88B6C9B1C1}"/>
          </ac:cxnSpMkLst>
        </pc:cxnChg>
        <pc:cxnChg chg="add mod">
          <ac:chgData name="Tekle Pauzaite" userId="06f7e524-8501-4f81-9b2a-484f6f2c7061" providerId="ADAL" clId="{CDBE4533-5B9D-4EDB-97E2-67A1ACDDDCEA}" dt="2024-03-27T14:15:05.680" v="9" actId="1076"/>
          <ac:cxnSpMkLst>
            <pc:docMk/>
            <pc:sldMk cId="3168164263" sldId="256"/>
            <ac:cxnSpMk id="47" creationId="{285E4423-E7DB-447B-B01C-640CACE95355}"/>
          </ac:cxnSpMkLst>
        </pc:cxnChg>
      </pc:sldChg>
      <pc:sldChg chg="addSp delSp modSp add">
        <pc:chgData name="Tekle Pauzaite" userId="06f7e524-8501-4f81-9b2a-484f6f2c7061" providerId="ADAL" clId="{CDBE4533-5B9D-4EDB-97E2-67A1ACDDDCEA}" dt="2024-03-27T14:19:52.160" v="149" actId="571"/>
        <pc:sldMkLst>
          <pc:docMk/>
          <pc:sldMk cId="325301696" sldId="257"/>
        </pc:sldMkLst>
        <pc:spChg chg="add mod">
          <ac:chgData name="Tekle Pauzaite" userId="06f7e524-8501-4f81-9b2a-484f6f2c7061" providerId="ADAL" clId="{CDBE4533-5B9D-4EDB-97E2-67A1ACDDDCEA}" dt="2024-03-27T14:14:55.912" v="6" actId="1076"/>
          <ac:spMkLst>
            <pc:docMk/>
            <pc:sldMk cId="325301696" sldId="257"/>
            <ac:spMk id="2" creationId="{2BDFCD08-C388-4F06-A680-8879D29A9776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8" creationId="{1118FA2F-0567-49E4-938B-0D103E4A7709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9" creationId="{0E5C0E6E-42FD-4573-A54A-5CF75F6E4F8D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0" creationId="{3C9C5C40-0436-41C1-833A-43F7AC64509B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1" creationId="{4417C731-B995-48BF-AB4B-CA98904B3834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2" creationId="{B4FD7367-51FB-4D4D-96E3-C103A67FD785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3" creationId="{DE459A9D-1740-42DF-ACDF-45C14567B660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4" creationId="{260BED64-D4AA-48FA-9386-77E12B8D64CA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5" creationId="{9D59C316-AB62-47A3-95A6-9940F25990CC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6" creationId="{21A8C58C-B6D2-479C-9D2B-687CF560E5A8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17" creationId="{20BC3FA7-F267-481C-9058-D2EC3210B2C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22" creationId="{ED5C4D1C-982C-49D1-8D98-DDE772949A21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24" creationId="{D60604C0-9309-4149-A1B6-3E472D2E1F2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26" creationId="{B45AE273-7577-4950-857B-60D4F0EA35DA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27" creationId="{B87662B5-F3F5-4BF0-B8E4-A013B7778059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0" creationId="{63192E57-00DA-492E-8063-B2B8D358F116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1" creationId="{0968E131-0510-4949-9EF7-59102BB783EC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2" creationId="{F7909FCB-B441-4E08-AA6E-FF5C146F3CB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3" creationId="{D8F7420F-9D6C-416A-88E8-896D5E86846A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4" creationId="{D8AFBD00-58E0-49CC-9633-6A41471F6B07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5" creationId="{2B112C9E-B593-45D7-BC28-841711C6CBFB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6" creationId="{78ECC6AE-A47C-4ACC-A2F5-89A6D2D5C4A8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7" creationId="{08AED0CA-8DAC-4FDE-898F-101851426115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8" creationId="{68640F6D-76A9-479F-9C7D-C75810481E34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39" creationId="{56143098-25CE-470F-B596-3431A6B921CE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0" creationId="{F73FD665-7DA1-43F7-889A-EC5FD9EFEA6B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1" creationId="{4DB8F4AB-4280-49E3-B408-1F67FF51D6C7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3" creationId="{57E27085-CA4A-4669-A5FE-0C77D08DF1EA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4" creationId="{5BD904E8-A5AA-4DBB-BDF1-9F91EE3507C0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5" creationId="{63271C83-CE20-4E09-833C-13A0B6A4972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6" creationId="{35A4A64C-9A89-4A17-8AF3-2204D22994F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7" creationId="{ED863420-69D7-494D-A1F8-ECE0451B3A72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8" creationId="{9A15032C-794A-4BB3-A654-C138921EFDE3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49" creationId="{01B1C117-2769-45BF-9E09-3AA53BE1E0FF}"/>
          </ac:spMkLst>
        </pc:spChg>
        <pc:spChg chg="mod topLvl">
          <ac:chgData name="Tekle Pauzaite" userId="06f7e524-8501-4f81-9b2a-484f6f2c7061" providerId="ADAL" clId="{CDBE4533-5B9D-4EDB-97E2-67A1ACDDDCEA}" dt="2024-03-27T14:17:19.170" v="72" actId="165"/>
          <ac:spMkLst>
            <pc:docMk/>
            <pc:sldMk cId="325301696" sldId="257"/>
            <ac:spMk id="50" creationId="{FF1F1C04-E9FD-4829-BCC7-D2331D6C089B}"/>
          </ac:spMkLst>
        </pc:spChg>
        <pc:spChg chg="add mod">
          <ac:chgData name="Tekle Pauzaite" userId="06f7e524-8501-4f81-9b2a-484f6f2c7061" providerId="ADAL" clId="{CDBE4533-5B9D-4EDB-97E2-67A1ACDDDCEA}" dt="2024-03-27T14:19:00.719" v="137" actId="1076"/>
          <ac:spMkLst>
            <pc:docMk/>
            <pc:sldMk cId="325301696" sldId="257"/>
            <ac:spMk id="56" creationId="{B047EA71-631B-42A4-AD9D-3BD82FE6456A}"/>
          </ac:spMkLst>
        </pc:spChg>
        <pc:spChg chg="add mod">
          <ac:chgData name="Tekle Pauzaite" userId="06f7e524-8501-4f81-9b2a-484f6f2c7061" providerId="ADAL" clId="{CDBE4533-5B9D-4EDB-97E2-67A1ACDDDCEA}" dt="2024-03-27T14:19:08.737" v="139" actId="14100"/>
          <ac:spMkLst>
            <pc:docMk/>
            <pc:sldMk cId="325301696" sldId="257"/>
            <ac:spMk id="57" creationId="{8BAB4E60-06F8-40EB-9245-A6B9B9D468FD}"/>
          </ac:spMkLst>
        </pc:spChg>
        <pc:spChg chg="add mod">
          <ac:chgData name="Tekle Pauzaite" userId="06f7e524-8501-4f81-9b2a-484f6f2c7061" providerId="ADAL" clId="{CDBE4533-5B9D-4EDB-97E2-67A1ACDDDCEA}" dt="2024-03-27T14:19:15.680" v="140" actId="571"/>
          <ac:spMkLst>
            <pc:docMk/>
            <pc:sldMk cId="325301696" sldId="257"/>
            <ac:spMk id="58" creationId="{7885FA12-EC62-4556-89F8-53A53572C201}"/>
          </ac:spMkLst>
        </pc:spChg>
        <pc:spChg chg="add mod">
          <ac:chgData name="Tekle Pauzaite" userId="06f7e524-8501-4f81-9b2a-484f6f2c7061" providerId="ADAL" clId="{CDBE4533-5B9D-4EDB-97E2-67A1ACDDDCEA}" dt="2024-03-27T14:19:22.160" v="141" actId="571"/>
          <ac:spMkLst>
            <pc:docMk/>
            <pc:sldMk cId="325301696" sldId="257"/>
            <ac:spMk id="59" creationId="{F0C06AF1-106B-424A-94EB-BBBB6971CDEE}"/>
          </ac:spMkLst>
        </pc:spChg>
        <pc:spChg chg="add mod">
          <ac:chgData name="Tekle Pauzaite" userId="06f7e524-8501-4f81-9b2a-484f6f2c7061" providerId="ADAL" clId="{CDBE4533-5B9D-4EDB-97E2-67A1ACDDDCEA}" dt="2024-03-27T14:19:24.288" v="142" actId="571"/>
          <ac:spMkLst>
            <pc:docMk/>
            <pc:sldMk cId="325301696" sldId="257"/>
            <ac:spMk id="60" creationId="{1F62AD7C-718B-4FEB-B9F1-579AD8D5769D}"/>
          </ac:spMkLst>
        </pc:spChg>
        <pc:spChg chg="add mod">
          <ac:chgData name="Tekle Pauzaite" userId="06f7e524-8501-4f81-9b2a-484f6f2c7061" providerId="ADAL" clId="{CDBE4533-5B9D-4EDB-97E2-67A1ACDDDCEA}" dt="2024-03-27T14:19:29.128" v="143" actId="571"/>
          <ac:spMkLst>
            <pc:docMk/>
            <pc:sldMk cId="325301696" sldId="257"/>
            <ac:spMk id="61" creationId="{5CAD8036-EA99-4ED3-A255-6030642895EC}"/>
          </ac:spMkLst>
        </pc:spChg>
        <pc:spChg chg="add mod">
          <ac:chgData name="Tekle Pauzaite" userId="06f7e524-8501-4f81-9b2a-484f6f2c7061" providerId="ADAL" clId="{CDBE4533-5B9D-4EDB-97E2-67A1ACDDDCEA}" dt="2024-03-27T14:19:36.840" v="145" actId="14100"/>
          <ac:spMkLst>
            <pc:docMk/>
            <pc:sldMk cId="325301696" sldId="257"/>
            <ac:spMk id="62" creationId="{332A4BDE-ED02-4991-A6BB-0F911A1E8473}"/>
          </ac:spMkLst>
        </pc:spChg>
        <pc:spChg chg="add mod">
          <ac:chgData name="Tekle Pauzaite" userId="06f7e524-8501-4f81-9b2a-484f6f2c7061" providerId="ADAL" clId="{CDBE4533-5B9D-4EDB-97E2-67A1ACDDDCEA}" dt="2024-03-27T14:19:48.903" v="148" actId="1076"/>
          <ac:spMkLst>
            <pc:docMk/>
            <pc:sldMk cId="325301696" sldId="257"/>
            <ac:spMk id="63" creationId="{794F7672-C0C2-4B6A-8B61-1C33B1FF29F3}"/>
          </ac:spMkLst>
        </pc:spChg>
        <pc:spChg chg="add mod">
          <ac:chgData name="Tekle Pauzaite" userId="06f7e524-8501-4f81-9b2a-484f6f2c7061" providerId="ADAL" clId="{CDBE4533-5B9D-4EDB-97E2-67A1ACDDDCEA}" dt="2024-03-27T14:19:46.063" v="147" actId="571"/>
          <ac:spMkLst>
            <pc:docMk/>
            <pc:sldMk cId="325301696" sldId="257"/>
            <ac:spMk id="64" creationId="{2365594F-9343-49D8-A274-41D2C562D1E0}"/>
          </ac:spMkLst>
        </pc:spChg>
        <pc:spChg chg="add mod">
          <ac:chgData name="Tekle Pauzaite" userId="06f7e524-8501-4f81-9b2a-484f6f2c7061" providerId="ADAL" clId="{CDBE4533-5B9D-4EDB-97E2-67A1ACDDDCEA}" dt="2024-03-27T14:19:52.160" v="149" actId="571"/>
          <ac:spMkLst>
            <pc:docMk/>
            <pc:sldMk cId="325301696" sldId="257"/>
            <ac:spMk id="65" creationId="{CF573CE3-2EE3-487F-8DC5-D14F07701971}"/>
          </ac:spMkLst>
        </pc:spChg>
        <pc:grpChg chg="add del mod ord">
          <ac:chgData name="Tekle Pauzaite" userId="06f7e524-8501-4f81-9b2a-484f6f2c7061" providerId="ADAL" clId="{CDBE4533-5B9D-4EDB-97E2-67A1ACDDDCEA}" dt="2024-03-27T14:17:19.170" v="72" actId="165"/>
          <ac:grpSpMkLst>
            <pc:docMk/>
            <pc:sldMk cId="325301696" sldId="257"/>
            <ac:grpSpMk id="3" creationId="{3FA1A963-B3AE-462A-ABD1-D48C6CC89ED5}"/>
          </ac:grpSpMkLst>
        </pc:grpChg>
        <pc:picChg chg="mod topLvl">
          <ac:chgData name="Tekle Pauzaite" userId="06f7e524-8501-4f81-9b2a-484f6f2c7061" providerId="ADAL" clId="{CDBE4533-5B9D-4EDB-97E2-67A1ACDDDCEA}" dt="2024-03-27T14:17:19.170" v="72" actId="165"/>
          <ac:picMkLst>
            <pc:docMk/>
            <pc:sldMk cId="325301696" sldId="257"/>
            <ac:picMk id="4" creationId="{6A185F89-0E74-4435-8A69-B27D47BD1C76}"/>
          </ac:picMkLst>
        </pc:picChg>
        <pc:picChg chg="mod topLvl">
          <ac:chgData name="Tekle Pauzaite" userId="06f7e524-8501-4f81-9b2a-484f6f2c7061" providerId="ADAL" clId="{CDBE4533-5B9D-4EDB-97E2-67A1ACDDDCEA}" dt="2024-03-27T14:17:19.170" v="72" actId="165"/>
          <ac:picMkLst>
            <pc:docMk/>
            <pc:sldMk cId="325301696" sldId="257"/>
            <ac:picMk id="5" creationId="{DDC966E0-F341-49E5-98A1-D60812BA9BD7}"/>
          </ac:picMkLst>
        </pc:picChg>
        <pc:picChg chg="mod topLvl">
          <ac:chgData name="Tekle Pauzaite" userId="06f7e524-8501-4f81-9b2a-484f6f2c7061" providerId="ADAL" clId="{CDBE4533-5B9D-4EDB-97E2-67A1ACDDDCEA}" dt="2024-03-27T14:17:19.170" v="72" actId="165"/>
          <ac:picMkLst>
            <pc:docMk/>
            <pc:sldMk cId="325301696" sldId="257"/>
            <ac:picMk id="6" creationId="{DE8D7F20-1A44-4979-B456-6AB3ADB3CD12}"/>
          </ac:picMkLst>
        </pc:picChg>
        <pc:picChg chg="mod topLvl">
          <ac:chgData name="Tekle Pauzaite" userId="06f7e524-8501-4f81-9b2a-484f6f2c7061" providerId="ADAL" clId="{CDBE4533-5B9D-4EDB-97E2-67A1ACDDDCEA}" dt="2024-03-27T14:17:19.170" v="72" actId="165"/>
          <ac:picMkLst>
            <pc:docMk/>
            <pc:sldMk cId="325301696" sldId="257"/>
            <ac:picMk id="7" creationId="{8EFE026B-9446-4182-9F24-57C05878F8AA}"/>
          </ac:picMkLst>
        </pc:picChg>
        <pc:picChg chg="mod topLvl">
          <ac:chgData name="Tekle Pauzaite" userId="06f7e524-8501-4f81-9b2a-484f6f2c7061" providerId="ADAL" clId="{CDBE4533-5B9D-4EDB-97E2-67A1ACDDDCEA}" dt="2024-03-27T14:17:19.170" v="72" actId="165"/>
          <ac:picMkLst>
            <pc:docMk/>
            <pc:sldMk cId="325301696" sldId="257"/>
            <ac:picMk id="25" creationId="{E147F9DE-41EB-4699-A122-9FED811A0C65}"/>
          </ac:picMkLst>
        </pc:picChg>
        <pc:picChg chg="add mod modCrop">
          <ac:chgData name="Tekle Pauzaite" userId="06f7e524-8501-4f81-9b2a-484f6f2c7061" providerId="ADAL" clId="{CDBE4533-5B9D-4EDB-97E2-67A1ACDDDCEA}" dt="2024-03-27T14:17:44.967" v="89" actId="1076"/>
          <ac:picMkLst>
            <pc:docMk/>
            <pc:sldMk cId="325301696" sldId="257"/>
            <ac:picMk id="52" creationId="{FC95181B-65E2-4BCE-B958-EB10C5B0DF99}"/>
          </ac:picMkLst>
        </pc:picChg>
        <pc:picChg chg="add mod modCrop">
          <ac:chgData name="Tekle Pauzaite" userId="06f7e524-8501-4f81-9b2a-484f6f2c7061" providerId="ADAL" clId="{CDBE4533-5B9D-4EDB-97E2-67A1ACDDDCEA}" dt="2024-03-27T14:18:15.399" v="118" actId="1076"/>
          <ac:picMkLst>
            <pc:docMk/>
            <pc:sldMk cId="325301696" sldId="257"/>
            <ac:picMk id="53" creationId="{8F826338-E337-48B7-B507-690B081496E1}"/>
          </ac:picMkLst>
        </pc:picChg>
        <pc:picChg chg="add mod modCrop">
          <ac:chgData name="Tekle Pauzaite" userId="06f7e524-8501-4f81-9b2a-484f6f2c7061" providerId="ADAL" clId="{CDBE4533-5B9D-4EDB-97E2-67A1ACDDDCEA}" dt="2024-03-27T14:18:53.431" v="135" actId="1076"/>
          <ac:picMkLst>
            <pc:docMk/>
            <pc:sldMk cId="325301696" sldId="257"/>
            <ac:picMk id="54" creationId="{DADF676A-5998-427D-9D38-1D00CC0D3C3A}"/>
          </ac:picMkLst>
        </pc:picChg>
        <pc:picChg chg="add del mod modCrop">
          <ac:chgData name="Tekle Pauzaite" userId="06f7e524-8501-4f81-9b2a-484f6f2c7061" providerId="ADAL" clId="{CDBE4533-5B9D-4EDB-97E2-67A1ACDDDCEA}" dt="2024-03-27T14:18:51.330" v="134" actId="478"/>
          <ac:picMkLst>
            <pc:docMk/>
            <pc:sldMk cId="325301696" sldId="257"/>
            <ac:picMk id="55" creationId="{B52A6A3C-5353-43BF-B9D9-D5E9FFD853D3}"/>
          </ac:picMkLst>
        </pc:pic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18" creationId="{FB7B6996-F64F-41F2-AF6D-CD8921D10560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19" creationId="{86E9CB11-3E37-4B5E-A17B-51AEC241218E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20" creationId="{63FC7960-9CA6-469C-830B-426DF73AE0AE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21" creationId="{676C171D-FE5C-469D-8932-AE3F63257A2D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23" creationId="{D9482607-678C-4308-9864-AE0602CDFFC4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28" creationId="{86604AAC-B945-40FF-B5EF-93798CCCBD03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29" creationId="{E19A405B-C3FF-4867-856A-9C8AA7380497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42" creationId="{1246FE0B-5D16-4E8F-A5FE-1E0B77E62E0E}"/>
          </ac:cxnSpMkLst>
        </pc:cxnChg>
        <pc:cxnChg chg="mod topLvl">
          <ac:chgData name="Tekle Pauzaite" userId="06f7e524-8501-4f81-9b2a-484f6f2c7061" providerId="ADAL" clId="{CDBE4533-5B9D-4EDB-97E2-67A1ACDDDCEA}" dt="2024-03-27T14:17:19.170" v="72" actId="165"/>
          <ac:cxnSpMkLst>
            <pc:docMk/>
            <pc:sldMk cId="325301696" sldId="257"/>
            <ac:cxnSpMk id="51" creationId="{7C4AC534-9135-44F7-B7C7-A9DD695D23C6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565B9-C291-4F89-A967-29B8E025E0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405DD8-FFE7-4D06-822D-4979A2A2E8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120496-4E2B-4D3A-A296-00D38917D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181CC4-710C-48DA-9958-50B82FB1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04FCF2-48CB-4790-8BC8-8B995A9A4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0137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B47E0-DF48-4F3C-9757-01158DD5F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49EFC7-3600-43E0-9E07-90CE7B8DA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85A300-B4C2-44BA-9DA7-247853A4E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8A544C-05EA-46FC-95F3-B84865989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8477FB-230E-4B42-9E82-6D0B087BE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824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24908C-2428-452C-BAB1-5CB40C53EC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317348-680E-40A3-87CC-F6435051D5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9C0D88-F8F5-4288-BE57-F1AD14BBB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074A50-DE47-4C47-B4CE-8C7275A63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0A6532-D7E8-4DF8-8B4F-D0E07FED8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560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80496-28C9-4EE4-82CA-AB4ABA1C4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E8115B-A5E7-479B-8864-8188EEC88C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B35231-A0DC-4FE4-B416-7F949E2C9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5EB1C0-A19A-4E6E-9568-CA87B39B1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74351-06AA-4F61-897D-FF2526464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846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A97E1D-7915-47A8-BF00-DB23061F2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1124D4-F2FF-4F3C-9BE7-F118C05FA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E292C1-9494-4CE3-A8F5-AE928EBDA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06D7A-9F74-4D75-91F2-6ECB993D2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8F394-502A-48F2-8EC3-DF6007C4F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449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43EE09-7A08-4BC4-9C6A-DE5694609D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A473D8-6D04-4BAC-9CB2-E80FFB1E10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8E55F6-3348-43E3-9CF6-F5EED78B90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4282F6-237E-4ACA-91DD-6F54FFA49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CB7F9-F028-4122-8902-7145815ED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4FEE4C-E896-464B-AA1A-8ED13A94B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4156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B82AF-BF48-4BAC-ACBC-6D608FB72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6111F1-13B6-4263-9B5E-11DB8B5691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439287-0F0F-41EC-B7E7-5B55084900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9B932C-023D-47F9-89AC-AD361703B7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5CF593-E822-4DA9-AE92-096907E918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FC8DA2-6651-4741-9F19-3429FB267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7E3B1E-A692-45ED-B22F-238CA88BF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5D74657-4530-4A5A-9397-22E6131B3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980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43BC7-E3B1-4858-9DD3-D965113B1D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B62EB4-8AB5-4F7F-84E2-1BB5C03D8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0BC0CB-334D-49A7-AFF3-EAFB2168F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5E021F9-99A2-4ABF-B988-4857AC2A6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8322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78496F-89C0-4B5C-B551-90C241F27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F21E7B-F452-4B11-90B0-6B168C70B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6908FE-D01F-43D0-9CD2-28B3EB756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042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3C22E0-61D2-4694-A15A-679FDE8B0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648C6C-6C9D-480C-A7AB-8B1705F2D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EF22BE-276A-4224-8C7C-189E45D16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C7A6C9-6760-47AA-A630-D169D4765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D8B4AA-DFC5-4BA9-9C48-D01C5A47E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53227C-8FB5-44F8-97B5-AEF4633A0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057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2BA7C-694A-43FD-8000-8751AEEC7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E16AC9-6A76-46D8-8047-6D037F3DC4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4C72AF-3952-4D51-849F-29BA77F7BF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01042E-0A24-4CF9-9EC5-FCBA16F2C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A2C23-BFEB-4698-98C0-A099C6B4C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64C217-7305-4B5F-ABCA-9031CA8B1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007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8C1570-17BC-4A1D-9E73-AAFFD12D4C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AE7E0F-5BA4-4EED-B2FD-3DC57EBD2B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244B6F-AB8F-4708-82ED-F4E4C44A54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4BE6D-6F9C-4127-9501-DAAEEB909E25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D78228-DDE1-4012-9A7E-AE49D9C5FE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EDD5A1-E78A-4CE8-9C50-0FA1D52C23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B091A-D783-4EA5-90E1-3EE0457981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136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5F8BDC-1DC5-40C8-9977-A2F5BAC37D19}"/>
              </a:ext>
            </a:extLst>
          </p:cNvPr>
          <p:cNvSpPr txBox="1"/>
          <p:nvPr/>
        </p:nvSpPr>
        <p:spPr>
          <a:xfrm>
            <a:off x="138901" y="5416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84312AC-2606-4DC9-BEB7-CDD1B3B9737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24" t="57124" r="73484" b="18625"/>
          <a:stretch/>
        </p:blipFill>
        <p:spPr>
          <a:xfrm rot="5400000">
            <a:off x="1072823" y="626230"/>
            <a:ext cx="372572" cy="14267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190980C-FC84-4780-8BA9-8797CCECEEA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37" t="57484" r="63471" b="18265"/>
          <a:stretch/>
        </p:blipFill>
        <p:spPr>
          <a:xfrm rot="5400000">
            <a:off x="1072823" y="1022090"/>
            <a:ext cx="372572" cy="14267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9D00DDA-2FE7-49A1-A5EE-FF848CBC929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5" t="60001" r="75727" b="15576"/>
          <a:stretch/>
        </p:blipFill>
        <p:spPr>
          <a:xfrm rot="5400000">
            <a:off x="1072823" y="237123"/>
            <a:ext cx="372571" cy="1426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E6E1338-FCD7-46A2-815B-C3AF7E855F8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45" t="58837" r="56625" b="17048"/>
          <a:stretch/>
        </p:blipFill>
        <p:spPr>
          <a:xfrm rot="5400000">
            <a:off x="1072821" y="1417951"/>
            <a:ext cx="372573" cy="14267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8DDEB40-C8CF-43A1-9333-C236CBE8E1D8}"/>
              </a:ext>
            </a:extLst>
          </p:cNvPr>
          <p:cNvSpPr txBox="1"/>
          <p:nvPr/>
        </p:nvSpPr>
        <p:spPr>
          <a:xfrm>
            <a:off x="1189932" y="527141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 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469A2D-FE4C-4268-8134-52642B9D14F0}"/>
              </a:ext>
            </a:extLst>
          </p:cNvPr>
          <p:cNvSpPr txBox="1"/>
          <p:nvPr/>
        </p:nvSpPr>
        <p:spPr>
          <a:xfrm>
            <a:off x="1338790" y="527141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9C90505-9C8E-47AA-86E1-01FC4C03B8C5}"/>
              </a:ext>
            </a:extLst>
          </p:cNvPr>
          <p:cNvSpPr txBox="1"/>
          <p:nvPr/>
        </p:nvSpPr>
        <p:spPr>
          <a:xfrm>
            <a:off x="1533473" y="527141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16C9802-6D18-45E0-88F9-0120D8E782D8}"/>
              </a:ext>
            </a:extLst>
          </p:cNvPr>
          <p:cNvSpPr txBox="1"/>
          <p:nvPr/>
        </p:nvSpPr>
        <p:spPr>
          <a:xfrm>
            <a:off x="1682333" y="527141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7D4030-4444-4659-A36E-3A024FFF2D01}"/>
              </a:ext>
            </a:extLst>
          </p:cNvPr>
          <p:cNvSpPr txBox="1"/>
          <p:nvPr/>
        </p:nvSpPr>
        <p:spPr>
          <a:xfrm>
            <a:off x="1261594" y="372528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D2AB0A-6834-46A7-BAFC-94E6CB0724F1}"/>
              </a:ext>
            </a:extLst>
          </p:cNvPr>
          <p:cNvSpPr txBox="1"/>
          <p:nvPr/>
        </p:nvSpPr>
        <p:spPr>
          <a:xfrm>
            <a:off x="1573060" y="385228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F2EE96-97B1-4592-8B5E-AD3D21056185}"/>
              </a:ext>
            </a:extLst>
          </p:cNvPr>
          <p:cNvSpPr txBox="1"/>
          <p:nvPr/>
        </p:nvSpPr>
        <p:spPr>
          <a:xfrm>
            <a:off x="1427487" y="372528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F2BD75-8DB2-4FEB-B6DD-C2338C1C9CAC}"/>
              </a:ext>
            </a:extLst>
          </p:cNvPr>
          <p:cNvSpPr txBox="1"/>
          <p:nvPr/>
        </p:nvSpPr>
        <p:spPr>
          <a:xfrm>
            <a:off x="1756411" y="385228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F86C1A-20DE-4832-B588-34A735E6BE16}"/>
              </a:ext>
            </a:extLst>
          </p:cNvPr>
          <p:cNvSpPr txBox="1"/>
          <p:nvPr/>
        </p:nvSpPr>
        <p:spPr>
          <a:xfrm>
            <a:off x="1949066" y="387443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39C6792-F0E6-466A-8AC7-EC709F695B00}"/>
              </a:ext>
            </a:extLst>
          </p:cNvPr>
          <p:cNvSpPr txBox="1"/>
          <p:nvPr/>
        </p:nvSpPr>
        <p:spPr>
          <a:xfrm>
            <a:off x="1943628" y="87167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742D2F3-AE6C-4B06-9F02-AB030EC9627A}"/>
              </a:ext>
            </a:extLst>
          </p:cNvPr>
          <p:cNvSpPr txBox="1"/>
          <p:nvPr/>
        </p:nvSpPr>
        <p:spPr>
          <a:xfrm>
            <a:off x="1943631" y="1282831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11A33A2-D8E7-4011-A1EA-D5FD272F3671}"/>
              </a:ext>
            </a:extLst>
          </p:cNvPr>
          <p:cNvSpPr txBox="1"/>
          <p:nvPr/>
        </p:nvSpPr>
        <p:spPr>
          <a:xfrm>
            <a:off x="1943631" y="1626808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A2995B-F86A-4EA7-B025-EE12397115AE}"/>
              </a:ext>
            </a:extLst>
          </p:cNvPr>
          <p:cNvSpPr txBox="1"/>
          <p:nvPr/>
        </p:nvSpPr>
        <p:spPr>
          <a:xfrm>
            <a:off x="1943631" y="2065900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D6B3969-2D0F-4876-90EE-BA87FF537BCD}"/>
              </a:ext>
            </a:extLst>
          </p:cNvPr>
          <p:cNvSpPr txBox="1"/>
          <p:nvPr/>
        </p:nvSpPr>
        <p:spPr>
          <a:xfrm>
            <a:off x="485517" y="203618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Cas9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504E476-0F1D-4B11-B4DF-08F80DB356B7}"/>
              </a:ext>
            </a:extLst>
          </p:cNvPr>
          <p:cNvSpPr txBox="1"/>
          <p:nvPr/>
        </p:nvSpPr>
        <p:spPr>
          <a:xfrm>
            <a:off x="1248619" y="203618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EE873AA-DCFB-4DEF-BFD6-17689FDC5BA9}"/>
              </a:ext>
            </a:extLst>
          </p:cNvPr>
          <p:cNvCxnSpPr/>
          <p:nvPr/>
        </p:nvCxnSpPr>
        <p:spPr>
          <a:xfrm>
            <a:off x="1353728" y="415113"/>
            <a:ext cx="54304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728C6217-D6EF-4930-975B-0F4E648AAD1C}"/>
              </a:ext>
            </a:extLst>
          </p:cNvPr>
          <p:cNvSpPr txBox="1"/>
          <p:nvPr/>
        </p:nvSpPr>
        <p:spPr>
          <a:xfrm>
            <a:off x="466437" y="2313391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Chomati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extractio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25836D1-6086-42E5-9349-0ADDD96454FC}"/>
              </a:ext>
            </a:extLst>
          </p:cNvPr>
          <p:cNvSpPr txBox="1"/>
          <p:nvPr/>
        </p:nvSpPr>
        <p:spPr>
          <a:xfrm>
            <a:off x="130367" y="47347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EABB870-02BE-4096-9F11-F21D36B02C1F}"/>
              </a:ext>
            </a:extLst>
          </p:cNvPr>
          <p:cNvSpPr txBox="1"/>
          <p:nvPr/>
        </p:nvSpPr>
        <p:spPr>
          <a:xfrm>
            <a:off x="141768" y="67095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AD7F12E-5F43-430D-8AE7-7E1E33090B7C}"/>
              </a:ext>
            </a:extLst>
          </p:cNvPr>
          <p:cNvSpPr txBox="1"/>
          <p:nvPr/>
        </p:nvSpPr>
        <p:spPr>
          <a:xfrm>
            <a:off x="189943" y="99485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3B288FD-2C1A-46BC-B574-BEBE6BA97E00}"/>
              </a:ext>
            </a:extLst>
          </p:cNvPr>
          <p:cNvSpPr txBox="1"/>
          <p:nvPr/>
        </p:nvSpPr>
        <p:spPr>
          <a:xfrm>
            <a:off x="189943" y="162918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C6A2F46-3B56-4DDA-AC8A-204BC8A69A4A}"/>
              </a:ext>
            </a:extLst>
          </p:cNvPr>
          <p:cNvSpPr txBox="1"/>
          <p:nvPr/>
        </p:nvSpPr>
        <p:spPr>
          <a:xfrm>
            <a:off x="189943" y="18619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560F114-0B55-4079-95EB-1F9692710703}"/>
              </a:ext>
            </a:extLst>
          </p:cNvPr>
          <p:cNvSpPr txBox="1"/>
          <p:nvPr/>
        </p:nvSpPr>
        <p:spPr>
          <a:xfrm>
            <a:off x="189943" y="128888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9D9E926-C8C1-45C6-B13F-84CE2200A4C4}"/>
              </a:ext>
            </a:extLst>
          </p:cNvPr>
          <p:cNvCxnSpPr/>
          <p:nvPr/>
        </p:nvCxnSpPr>
        <p:spPr>
          <a:xfrm>
            <a:off x="443223" y="110517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7A90729-B5B0-4C5C-B15B-66403A55AEBB}"/>
              </a:ext>
            </a:extLst>
          </p:cNvPr>
          <p:cNvCxnSpPr/>
          <p:nvPr/>
        </p:nvCxnSpPr>
        <p:spPr>
          <a:xfrm>
            <a:off x="443223" y="140025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FE093B1-5D36-46DE-85DD-FD4C76110D65}"/>
              </a:ext>
            </a:extLst>
          </p:cNvPr>
          <p:cNvCxnSpPr/>
          <p:nvPr/>
        </p:nvCxnSpPr>
        <p:spPr>
          <a:xfrm>
            <a:off x="443223" y="174147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6D429A4-6A20-4467-9706-D91CC4539B3F}"/>
              </a:ext>
            </a:extLst>
          </p:cNvPr>
          <p:cNvCxnSpPr/>
          <p:nvPr/>
        </p:nvCxnSpPr>
        <p:spPr>
          <a:xfrm>
            <a:off x="443223" y="198357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3BB9288A-B131-4550-B47F-DAB848F9A7FB}"/>
              </a:ext>
            </a:extLst>
          </p:cNvPr>
          <p:cNvSpPr txBox="1"/>
          <p:nvPr/>
        </p:nvSpPr>
        <p:spPr>
          <a:xfrm>
            <a:off x="189943" y="213453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536EC2B9-E71B-4638-B8EB-9F88B6C9B1C1}"/>
              </a:ext>
            </a:extLst>
          </p:cNvPr>
          <p:cNvCxnSpPr/>
          <p:nvPr/>
        </p:nvCxnSpPr>
        <p:spPr>
          <a:xfrm>
            <a:off x="443223" y="225612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BA6137E0-2FEF-43A2-861B-D54F9E9888BC}"/>
              </a:ext>
            </a:extLst>
          </p:cNvPr>
          <p:cNvSpPr txBox="1"/>
          <p:nvPr/>
        </p:nvSpPr>
        <p:spPr>
          <a:xfrm>
            <a:off x="466437" y="527828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F536286-ED89-4409-8803-D06DE661DF41}"/>
              </a:ext>
            </a:extLst>
          </p:cNvPr>
          <p:cNvSpPr txBox="1"/>
          <p:nvPr/>
        </p:nvSpPr>
        <p:spPr>
          <a:xfrm>
            <a:off x="615295" y="527828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4591582-0FD0-481B-984F-6FE753FD7A88}"/>
              </a:ext>
            </a:extLst>
          </p:cNvPr>
          <p:cNvSpPr txBox="1"/>
          <p:nvPr/>
        </p:nvSpPr>
        <p:spPr>
          <a:xfrm>
            <a:off x="809978" y="527828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49337C-819E-4414-9A26-7DB8CEBED212}"/>
              </a:ext>
            </a:extLst>
          </p:cNvPr>
          <p:cNvSpPr txBox="1"/>
          <p:nvPr/>
        </p:nvSpPr>
        <p:spPr>
          <a:xfrm>
            <a:off x="943598" y="527828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413B278-6C8E-42CF-B659-586B3103278B}"/>
              </a:ext>
            </a:extLst>
          </p:cNvPr>
          <p:cNvSpPr txBox="1"/>
          <p:nvPr/>
        </p:nvSpPr>
        <p:spPr>
          <a:xfrm>
            <a:off x="499999" y="37321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A965E2-6B5C-491E-847C-AEC5DBCC2A84}"/>
              </a:ext>
            </a:extLst>
          </p:cNvPr>
          <p:cNvSpPr txBox="1"/>
          <p:nvPr/>
        </p:nvSpPr>
        <p:spPr>
          <a:xfrm>
            <a:off x="819085" y="38591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C5ADEAA-BED6-4F57-B3E0-A5EADF05534D}"/>
              </a:ext>
            </a:extLst>
          </p:cNvPr>
          <p:cNvSpPr txBox="1"/>
          <p:nvPr/>
        </p:nvSpPr>
        <p:spPr>
          <a:xfrm>
            <a:off x="665892" y="37321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F87B009-80E1-4164-9FE0-CD98CCD3F2FE}"/>
              </a:ext>
            </a:extLst>
          </p:cNvPr>
          <p:cNvSpPr txBox="1"/>
          <p:nvPr/>
        </p:nvSpPr>
        <p:spPr>
          <a:xfrm>
            <a:off x="1002436" y="38591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285E4423-E7DB-447B-B01C-640CACE95355}"/>
              </a:ext>
            </a:extLst>
          </p:cNvPr>
          <p:cNvCxnSpPr/>
          <p:nvPr/>
        </p:nvCxnSpPr>
        <p:spPr>
          <a:xfrm>
            <a:off x="592133" y="415800"/>
            <a:ext cx="54304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7" name="Picture 96">
            <a:extLst>
              <a:ext uri="{FF2B5EF4-FFF2-40B4-BE49-F238E27FC236}">
                <a16:creationId xmlns:a16="http://schemas.microsoft.com/office/drawing/2014/main" id="{870AE733-C3DE-41F1-BD75-923E3A22D39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12" t="12" r="259" b="219"/>
          <a:stretch/>
        </p:blipFill>
        <p:spPr>
          <a:xfrm rot="5400000">
            <a:off x="3440989" y="-174326"/>
            <a:ext cx="2253587" cy="29909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28125AA3-E5FE-42FB-86DF-A1EFA1E0F00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" t="93" r="-592" b="459"/>
          <a:stretch/>
        </p:blipFill>
        <p:spPr>
          <a:xfrm rot="5400000">
            <a:off x="6508949" y="-168198"/>
            <a:ext cx="2280723" cy="3002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602F0A40-66C7-4634-BE28-8E8F0D82ABD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" t="89" r="307" b="662"/>
          <a:stretch/>
        </p:blipFill>
        <p:spPr>
          <a:xfrm rot="5400000">
            <a:off x="3588388" y="2282752"/>
            <a:ext cx="2282470" cy="30133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0" name="Rectangle 99">
            <a:extLst>
              <a:ext uri="{FF2B5EF4-FFF2-40B4-BE49-F238E27FC236}">
                <a16:creationId xmlns:a16="http://schemas.microsoft.com/office/drawing/2014/main" id="{D8E275D2-E26F-48AC-B2A9-53997DDE23E8}"/>
              </a:ext>
            </a:extLst>
          </p:cNvPr>
          <p:cNvSpPr/>
          <p:nvPr/>
        </p:nvSpPr>
        <p:spPr>
          <a:xfrm>
            <a:off x="3467100" y="581748"/>
            <a:ext cx="919956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C68C5409-EF30-4F98-A84E-8E501A4201EC}"/>
              </a:ext>
            </a:extLst>
          </p:cNvPr>
          <p:cNvSpPr/>
          <p:nvPr/>
        </p:nvSpPr>
        <p:spPr>
          <a:xfrm>
            <a:off x="6619004" y="581748"/>
            <a:ext cx="919956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F88F5E0A-40F4-4F3A-B9B6-8E6F6E843305}"/>
              </a:ext>
            </a:extLst>
          </p:cNvPr>
          <p:cNvSpPr/>
          <p:nvPr/>
        </p:nvSpPr>
        <p:spPr>
          <a:xfrm>
            <a:off x="6619004" y="832851"/>
            <a:ext cx="919956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76280EEE-81AD-4778-8B9C-5FF060A813EE}"/>
              </a:ext>
            </a:extLst>
          </p:cNvPr>
          <p:cNvSpPr/>
          <p:nvPr/>
        </p:nvSpPr>
        <p:spPr>
          <a:xfrm>
            <a:off x="3602372" y="3437995"/>
            <a:ext cx="919956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B4B1E2F-B448-4AF0-9426-DF067E19AE31}"/>
              </a:ext>
            </a:extLst>
          </p:cNvPr>
          <p:cNvSpPr txBox="1"/>
          <p:nvPr/>
        </p:nvSpPr>
        <p:spPr>
          <a:xfrm>
            <a:off x="3681947" y="34975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CC81B0B-0C77-417C-8953-C96FAE9959B7}"/>
              </a:ext>
            </a:extLst>
          </p:cNvPr>
          <p:cNvSpPr txBox="1"/>
          <p:nvPr/>
        </p:nvSpPr>
        <p:spPr>
          <a:xfrm>
            <a:off x="7542000" y="58168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7830F7D-CE30-4245-A534-926096DA9333}"/>
              </a:ext>
            </a:extLst>
          </p:cNvPr>
          <p:cNvSpPr txBox="1"/>
          <p:nvPr/>
        </p:nvSpPr>
        <p:spPr>
          <a:xfrm>
            <a:off x="7544408" y="825538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86F083D-B52F-462C-BB37-71CC6B1704BC}"/>
              </a:ext>
            </a:extLst>
          </p:cNvPr>
          <p:cNvSpPr txBox="1"/>
          <p:nvPr/>
        </p:nvSpPr>
        <p:spPr>
          <a:xfrm>
            <a:off x="3685374" y="3198168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</a:p>
        </p:txBody>
      </p:sp>
    </p:spTree>
    <p:extLst>
      <p:ext uri="{BB962C8B-B14F-4D97-AF65-F5344CB8AC3E}">
        <p14:creationId xmlns:p14="http://schemas.microsoft.com/office/powerpoint/2010/main" val="3168164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DFCD08-C388-4F06-A680-8879D29A9776}"/>
              </a:ext>
            </a:extLst>
          </p:cNvPr>
          <p:cNvSpPr txBox="1"/>
          <p:nvPr/>
        </p:nvSpPr>
        <p:spPr>
          <a:xfrm>
            <a:off x="246615" y="1431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A185F89-0E74-4435-8A69-B27D47BD1C7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81" t="28957" r="69442" b="44981"/>
          <a:stretch/>
        </p:blipFill>
        <p:spPr>
          <a:xfrm rot="5400000">
            <a:off x="1252331" y="1122325"/>
            <a:ext cx="372438" cy="14260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DC966E0-F341-49E5-98A1-D60812BA9BD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5" t="28651" r="61778" b="45287"/>
          <a:stretch/>
        </p:blipFill>
        <p:spPr>
          <a:xfrm rot="5400000">
            <a:off x="1252486" y="1522470"/>
            <a:ext cx="372438" cy="14260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E8D7F20-1A44-4979-B456-6AB3ADB3CD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69" t="56489" r="51354" b="17376"/>
          <a:stretch/>
        </p:blipFill>
        <p:spPr>
          <a:xfrm rot="5400000">
            <a:off x="1252331" y="320073"/>
            <a:ext cx="372438" cy="14260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EFE026B-9446-4182-9F24-57C05878F8A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10" t="56869" r="29668" b="16452"/>
          <a:stretch/>
        </p:blipFill>
        <p:spPr>
          <a:xfrm rot="5400000">
            <a:off x="1252331" y="1922614"/>
            <a:ext cx="372438" cy="14260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118FA2F-0567-49E4-938B-0D103E4A7709}"/>
              </a:ext>
            </a:extLst>
          </p:cNvPr>
          <p:cNvSpPr txBox="1"/>
          <p:nvPr/>
        </p:nvSpPr>
        <p:spPr>
          <a:xfrm>
            <a:off x="2126654" y="95432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E5C0E6E-42FD-4573-A54A-5CF75F6E4F8D}"/>
              </a:ext>
            </a:extLst>
          </p:cNvPr>
          <p:cNvSpPr txBox="1"/>
          <p:nvPr/>
        </p:nvSpPr>
        <p:spPr>
          <a:xfrm>
            <a:off x="2134148" y="1784354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9C5C40-0436-41C1-833A-43F7AC64509B}"/>
              </a:ext>
            </a:extLst>
          </p:cNvPr>
          <p:cNvSpPr txBox="1"/>
          <p:nvPr/>
        </p:nvSpPr>
        <p:spPr>
          <a:xfrm>
            <a:off x="2134148" y="2128331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17C731-B995-48BF-AB4B-CA98904B3834}"/>
              </a:ext>
            </a:extLst>
          </p:cNvPr>
          <p:cNvSpPr txBox="1"/>
          <p:nvPr/>
        </p:nvSpPr>
        <p:spPr>
          <a:xfrm>
            <a:off x="2134148" y="2567423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FD7367-51FB-4D4D-96E3-C103A67FD785}"/>
              </a:ext>
            </a:extLst>
          </p:cNvPr>
          <p:cNvSpPr txBox="1"/>
          <p:nvPr/>
        </p:nvSpPr>
        <p:spPr>
          <a:xfrm>
            <a:off x="312238" y="54568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459A9D-1740-42DF-ACDF-45C14567B660}"/>
              </a:ext>
            </a:extLst>
          </p:cNvPr>
          <p:cNvSpPr txBox="1"/>
          <p:nvPr/>
        </p:nvSpPr>
        <p:spPr>
          <a:xfrm>
            <a:off x="323639" y="74316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0BED64-D4AA-48FA-9386-77E12B8D64CA}"/>
              </a:ext>
            </a:extLst>
          </p:cNvPr>
          <p:cNvSpPr txBox="1"/>
          <p:nvPr/>
        </p:nvSpPr>
        <p:spPr>
          <a:xfrm>
            <a:off x="371814" y="1050290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59C316-AB62-47A3-95A6-9940F25990CC}"/>
              </a:ext>
            </a:extLst>
          </p:cNvPr>
          <p:cNvSpPr txBox="1"/>
          <p:nvPr/>
        </p:nvSpPr>
        <p:spPr>
          <a:xfrm>
            <a:off x="371814" y="211237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A8C58C-B6D2-479C-9D2B-687CF560E5A8}"/>
              </a:ext>
            </a:extLst>
          </p:cNvPr>
          <p:cNvSpPr txBox="1"/>
          <p:nvPr/>
        </p:nvSpPr>
        <p:spPr>
          <a:xfrm>
            <a:off x="371814" y="23451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0BC3FA7-F267-481C-9058-D2EC3210B2C2}"/>
              </a:ext>
            </a:extLst>
          </p:cNvPr>
          <p:cNvSpPr txBox="1"/>
          <p:nvPr/>
        </p:nvSpPr>
        <p:spPr>
          <a:xfrm>
            <a:off x="371814" y="177207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B7B6996-F64F-41F2-AF6D-CD8921D10560}"/>
              </a:ext>
            </a:extLst>
          </p:cNvPr>
          <p:cNvCxnSpPr/>
          <p:nvPr/>
        </p:nvCxnSpPr>
        <p:spPr>
          <a:xfrm>
            <a:off x="625094" y="116061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6E9CB11-3E37-4B5E-A17B-51AEC241218E}"/>
              </a:ext>
            </a:extLst>
          </p:cNvPr>
          <p:cNvCxnSpPr/>
          <p:nvPr/>
        </p:nvCxnSpPr>
        <p:spPr>
          <a:xfrm>
            <a:off x="625094" y="188344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3FC7960-9CA6-469C-830B-426DF73AE0AE}"/>
              </a:ext>
            </a:extLst>
          </p:cNvPr>
          <p:cNvCxnSpPr/>
          <p:nvPr/>
        </p:nvCxnSpPr>
        <p:spPr>
          <a:xfrm>
            <a:off x="625094" y="222467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76C171D-FE5C-469D-8932-AE3F63257A2D}"/>
              </a:ext>
            </a:extLst>
          </p:cNvPr>
          <p:cNvCxnSpPr/>
          <p:nvPr/>
        </p:nvCxnSpPr>
        <p:spPr>
          <a:xfrm>
            <a:off x="625094" y="246677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D5C4D1C-982C-49D1-8D98-DDE772949A21}"/>
              </a:ext>
            </a:extLst>
          </p:cNvPr>
          <p:cNvSpPr txBox="1"/>
          <p:nvPr/>
        </p:nvSpPr>
        <p:spPr>
          <a:xfrm>
            <a:off x="371814" y="26177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9482607-678C-4308-9864-AE0602CDFFC4}"/>
              </a:ext>
            </a:extLst>
          </p:cNvPr>
          <p:cNvCxnSpPr/>
          <p:nvPr/>
        </p:nvCxnSpPr>
        <p:spPr>
          <a:xfrm>
            <a:off x="625094" y="273932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60604C0-9309-4149-A1B6-3E472D2E1F22}"/>
              </a:ext>
            </a:extLst>
          </p:cNvPr>
          <p:cNvSpPr txBox="1"/>
          <p:nvPr/>
        </p:nvSpPr>
        <p:spPr>
          <a:xfrm>
            <a:off x="643745" y="2828033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Chomati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extraction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E147F9DE-41EB-4699-A122-9FED811A0C6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77" t="56944" r="52594" b="17501"/>
          <a:stretch/>
        </p:blipFill>
        <p:spPr>
          <a:xfrm rot="5400000">
            <a:off x="1249845" y="721422"/>
            <a:ext cx="374400" cy="1425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45AE273-7577-4950-857B-60D4F0EA35DA}"/>
              </a:ext>
            </a:extLst>
          </p:cNvPr>
          <p:cNvSpPr txBox="1"/>
          <p:nvPr/>
        </p:nvSpPr>
        <p:spPr>
          <a:xfrm>
            <a:off x="323639" y="114796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8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87662B5-F3F5-4BF0-B8E4-A013B7778059}"/>
              </a:ext>
            </a:extLst>
          </p:cNvPr>
          <p:cNvSpPr txBox="1"/>
          <p:nvPr/>
        </p:nvSpPr>
        <p:spPr>
          <a:xfrm>
            <a:off x="371814" y="147187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6604AAC-B945-40FF-B5EF-93798CCCBD03}"/>
              </a:ext>
            </a:extLst>
          </p:cNvPr>
          <p:cNvCxnSpPr/>
          <p:nvPr/>
        </p:nvCxnSpPr>
        <p:spPr>
          <a:xfrm>
            <a:off x="641872" y="126559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19A405B-C3FF-4867-856A-9C8AA7380497}"/>
              </a:ext>
            </a:extLst>
          </p:cNvPr>
          <p:cNvCxnSpPr/>
          <p:nvPr/>
        </p:nvCxnSpPr>
        <p:spPr>
          <a:xfrm>
            <a:off x="625094" y="158219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63192E57-00DA-492E-8063-B2B8D358F116}"/>
              </a:ext>
            </a:extLst>
          </p:cNvPr>
          <p:cNvSpPr txBox="1"/>
          <p:nvPr/>
        </p:nvSpPr>
        <p:spPr>
          <a:xfrm>
            <a:off x="2152231" y="1316251"/>
            <a:ext cx="1127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(high exp.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968E131-0510-4949-9EF7-59102BB783EC}"/>
              </a:ext>
            </a:extLst>
          </p:cNvPr>
          <p:cNvSpPr txBox="1"/>
          <p:nvPr/>
        </p:nvSpPr>
        <p:spPr>
          <a:xfrm>
            <a:off x="1366691" y="610956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 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909FCB-B441-4E08-AA6E-FF5C146F3CB2}"/>
              </a:ext>
            </a:extLst>
          </p:cNvPr>
          <p:cNvSpPr txBox="1"/>
          <p:nvPr/>
        </p:nvSpPr>
        <p:spPr>
          <a:xfrm>
            <a:off x="1515549" y="610956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8F7420F-9D6C-416A-88E8-896D5E86846A}"/>
              </a:ext>
            </a:extLst>
          </p:cNvPr>
          <p:cNvSpPr txBox="1"/>
          <p:nvPr/>
        </p:nvSpPr>
        <p:spPr>
          <a:xfrm>
            <a:off x="1710232" y="610956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8AFBD00-58E0-49CC-9633-6A41471F6B07}"/>
              </a:ext>
            </a:extLst>
          </p:cNvPr>
          <p:cNvSpPr txBox="1"/>
          <p:nvPr/>
        </p:nvSpPr>
        <p:spPr>
          <a:xfrm>
            <a:off x="1859092" y="610956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B112C9E-B593-45D7-BC28-841711C6CBFB}"/>
              </a:ext>
            </a:extLst>
          </p:cNvPr>
          <p:cNvSpPr txBox="1"/>
          <p:nvPr/>
        </p:nvSpPr>
        <p:spPr>
          <a:xfrm>
            <a:off x="1438353" y="456343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8ECC6AE-A47C-4ACC-A2F5-89A6D2D5C4A8}"/>
              </a:ext>
            </a:extLst>
          </p:cNvPr>
          <p:cNvSpPr txBox="1"/>
          <p:nvPr/>
        </p:nvSpPr>
        <p:spPr>
          <a:xfrm>
            <a:off x="1744739" y="469043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8AED0CA-8DAC-4FDE-898F-101851426115}"/>
              </a:ext>
            </a:extLst>
          </p:cNvPr>
          <p:cNvSpPr txBox="1"/>
          <p:nvPr/>
        </p:nvSpPr>
        <p:spPr>
          <a:xfrm>
            <a:off x="1604246" y="456343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8640F6D-76A9-479F-9C7D-C75810481E34}"/>
              </a:ext>
            </a:extLst>
          </p:cNvPr>
          <p:cNvSpPr txBox="1"/>
          <p:nvPr/>
        </p:nvSpPr>
        <p:spPr>
          <a:xfrm>
            <a:off x="1928090" y="469043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6143098-25CE-470F-B596-3431A6B921CE}"/>
              </a:ext>
            </a:extLst>
          </p:cNvPr>
          <p:cNvSpPr txBox="1"/>
          <p:nvPr/>
        </p:nvSpPr>
        <p:spPr>
          <a:xfrm>
            <a:off x="2125825" y="471258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73FD665-7DA1-43F7-889A-EC5FD9EFEA6B}"/>
              </a:ext>
            </a:extLst>
          </p:cNvPr>
          <p:cNvSpPr txBox="1"/>
          <p:nvPr/>
        </p:nvSpPr>
        <p:spPr>
          <a:xfrm>
            <a:off x="662276" y="287433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Cas9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DB8F4AB-4280-49E3-B408-1F67FF51D6C7}"/>
              </a:ext>
            </a:extLst>
          </p:cNvPr>
          <p:cNvSpPr txBox="1"/>
          <p:nvPr/>
        </p:nvSpPr>
        <p:spPr>
          <a:xfrm>
            <a:off x="1425378" y="287433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OE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246FE0B-5D16-4E8F-A5FE-1E0B77E62E0E}"/>
              </a:ext>
            </a:extLst>
          </p:cNvPr>
          <p:cNvCxnSpPr/>
          <p:nvPr/>
        </p:nvCxnSpPr>
        <p:spPr>
          <a:xfrm>
            <a:off x="1530487" y="498928"/>
            <a:ext cx="54304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7E27085-CA4A-4669-A5FE-0C77D08DF1EA}"/>
              </a:ext>
            </a:extLst>
          </p:cNvPr>
          <p:cNvSpPr txBox="1"/>
          <p:nvPr/>
        </p:nvSpPr>
        <p:spPr>
          <a:xfrm>
            <a:off x="643196" y="611643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BD904E8-A5AA-4DBB-BDF1-9F91EE3507C0}"/>
              </a:ext>
            </a:extLst>
          </p:cNvPr>
          <p:cNvSpPr txBox="1"/>
          <p:nvPr/>
        </p:nvSpPr>
        <p:spPr>
          <a:xfrm>
            <a:off x="792054" y="611643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3271C83-CE20-4E09-833C-13A0B6A49722}"/>
              </a:ext>
            </a:extLst>
          </p:cNvPr>
          <p:cNvSpPr txBox="1"/>
          <p:nvPr/>
        </p:nvSpPr>
        <p:spPr>
          <a:xfrm>
            <a:off x="986737" y="611643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5A4A64C-9A89-4A17-8AF3-2204D22994F2}"/>
              </a:ext>
            </a:extLst>
          </p:cNvPr>
          <p:cNvSpPr txBox="1"/>
          <p:nvPr/>
        </p:nvSpPr>
        <p:spPr>
          <a:xfrm>
            <a:off x="1120357" y="611643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D863420-69D7-494D-A1F8-ECE0451B3A72}"/>
              </a:ext>
            </a:extLst>
          </p:cNvPr>
          <p:cNvSpPr txBox="1"/>
          <p:nvPr/>
        </p:nvSpPr>
        <p:spPr>
          <a:xfrm>
            <a:off x="676758" y="457030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A15032C-794A-4BB3-A654-C138921EFDE3}"/>
              </a:ext>
            </a:extLst>
          </p:cNvPr>
          <p:cNvSpPr txBox="1"/>
          <p:nvPr/>
        </p:nvSpPr>
        <p:spPr>
          <a:xfrm>
            <a:off x="989494" y="469730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1B1C117-2769-45BF-9E09-3AA53BE1E0FF}"/>
              </a:ext>
            </a:extLst>
          </p:cNvPr>
          <p:cNvSpPr txBox="1"/>
          <p:nvPr/>
        </p:nvSpPr>
        <p:spPr>
          <a:xfrm>
            <a:off x="842651" y="457030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F1F1C04-E9FD-4829-BCC7-D2331D6C089B}"/>
              </a:ext>
            </a:extLst>
          </p:cNvPr>
          <p:cNvSpPr txBox="1"/>
          <p:nvPr/>
        </p:nvSpPr>
        <p:spPr>
          <a:xfrm>
            <a:off x="1172845" y="469730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C4AC534-9135-44F7-B7C7-A9DD695D23C6}"/>
              </a:ext>
            </a:extLst>
          </p:cNvPr>
          <p:cNvCxnSpPr/>
          <p:nvPr/>
        </p:nvCxnSpPr>
        <p:spPr>
          <a:xfrm>
            <a:off x="768892" y="499615"/>
            <a:ext cx="54304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2" name="Picture 51">
            <a:extLst>
              <a:ext uri="{FF2B5EF4-FFF2-40B4-BE49-F238E27FC236}">
                <a16:creationId xmlns:a16="http://schemas.microsoft.com/office/drawing/2014/main" id="{FC95181B-65E2-4BCE-B958-EB10C5B0DF9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" t="102" r="379" b="920"/>
          <a:stretch/>
        </p:blipFill>
        <p:spPr>
          <a:xfrm rot="5400000">
            <a:off x="3800802" y="-184028"/>
            <a:ext cx="3051176" cy="3688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8F826338-E337-48B7-B507-690B081496E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" t="1914" r="342" b="750"/>
          <a:stretch/>
        </p:blipFill>
        <p:spPr>
          <a:xfrm rot="5400000">
            <a:off x="7589386" y="-193992"/>
            <a:ext cx="3150835" cy="3708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DADF676A-5998-427D-9D38-1D00CC0D3C3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44" t="-308" r="107" b="-135"/>
          <a:stretch/>
        </p:blipFill>
        <p:spPr>
          <a:xfrm rot="5400000">
            <a:off x="3753584" y="3004807"/>
            <a:ext cx="3080598" cy="37537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id="{B047EA71-631B-42A4-AD9D-3BD82FE6456A}"/>
              </a:ext>
            </a:extLst>
          </p:cNvPr>
          <p:cNvSpPr/>
          <p:nvPr/>
        </p:nvSpPr>
        <p:spPr>
          <a:xfrm>
            <a:off x="4179348" y="1353191"/>
            <a:ext cx="919956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8BAB4E60-06F8-40EB-9245-A6B9B9D468FD}"/>
              </a:ext>
            </a:extLst>
          </p:cNvPr>
          <p:cNvSpPr/>
          <p:nvPr/>
        </p:nvSpPr>
        <p:spPr>
          <a:xfrm>
            <a:off x="7873037" y="1353191"/>
            <a:ext cx="1087321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7885FA12-EC62-4556-89F8-53A53572C201}"/>
              </a:ext>
            </a:extLst>
          </p:cNvPr>
          <p:cNvSpPr/>
          <p:nvPr/>
        </p:nvSpPr>
        <p:spPr>
          <a:xfrm>
            <a:off x="7873037" y="2081429"/>
            <a:ext cx="1087321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F0C06AF1-106B-424A-94EB-BBBB6971CDEE}"/>
              </a:ext>
            </a:extLst>
          </p:cNvPr>
          <p:cNvSpPr/>
          <p:nvPr/>
        </p:nvSpPr>
        <p:spPr>
          <a:xfrm>
            <a:off x="5008679" y="4034054"/>
            <a:ext cx="1087321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1F62AD7C-718B-4FEB-B9F1-579AD8D5769D}"/>
              </a:ext>
            </a:extLst>
          </p:cNvPr>
          <p:cNvSpPr/>
          <p:nvPr/>
        </p:nvSpPr>
        <p:spPr>
          <a:xfrm>
            <a:off x="5008679" y="4283882"/>
            <a:ext cx="1087321" cy="235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CAD8036-EA99-4ED3-A255-6030642895EC}"/>
              </a:ext>
            </a:extLst>
          </p:cNvPr>
          <p:cNvSpPr txBox="1"/>
          <p:nvPr/>
        </p:nvSpPr>
        <p:spPr>
          <a:xfrm>
            <a:off x="4326259" y="108541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32A4BDE-ED02-4991-A6BB-0F911A1E8473}"/>
              </a:ext>
            </a:extLst>
          </p:cNvPr>
          <p:cNvSpPr txBox="1"/>
          <p:nvPr/>
        </p:nvSpPr>
        <p:spPr>
          <a:xfrm>
            <a:off x="8999689" y="1353661"/>
            <a:ext cx="62056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(high exp.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94F7672-C0C2-4B6A-8B61-1C33B1FF29F3}"/>
              </a:ext>
            </a:extLst>
          </p:cNvPr>
          <p:cNvSpPr txBox="1"/>
          <p:nvPr/>
        </p:nvSpPr>
        <p:spPr>
          <a:xfrm>
            <a:off x="6164858" y="4034054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365594F-9343-49D8-A274-41D2C562D1E0}"/>
              </a:ext>
            </a:extLst>
          </p:cNvPr>
          <p:cNvSpPr txBox="1"/>
          <p:nvPr/>
        </p:nvSpPr>
        <p:spPr>
          <a:xfrm>
            <a:off x="6141608" y="4283882"/>
            <a:ext cx="668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F573CE3-2EE3-487F-8DC5-D14F07701971}"/>
              </a:ext>
            </a:extLst>
          </p:cNvPr>
          <p:cNvSpPr txBox="1"/>
          <p:nvPr/>
        </p:nvSpPr>
        <p:spPr>
          <a:xfrm>
            <a:off x="7993271" y="2336591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</a:p>
        </p:txBody>
      </p:sp>
    </p:spTree>
    <p:extLst>
      <p:ext uri="{BB962C8B-B14F-4D97-AF65-F5344CB8AC3E}">
        <p14:creationId xmlns:p14="http://schemas.microsoft.com/office/powerpoint/2010/main" val="325301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6</Words>
  <Application>Microsoft Office PowerPoint</Application>
  <PresentationFormat>Widescreen</PresentationFormat>
  <Paragraphs>7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3-27T14:14:37Z</dcterms:created>
  <dcterms:modified xsi:type="dcterms:W3CDTF">2024-03-27T14:19:57Z</dcterms:modified>
</cp:coreProperties>
</file>